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0" r:id="rId2"/>
    <p:sldId id="271" r:id="rId3"/>
    <p:sldId id="27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25" d="100"/>
          <a:sy n="125" d="100"/>
        </p:scale>
        <p:origin x="5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3ED443-899A-C04A-9700-B204AD8160D7}" type="datetimeFigureOut">
              <a:rPr lang="en-US" smtClean="0"/>
              <a:t>9/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ABB208-6FC7-D64A-BAE2-A5DF1D179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5909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A8BAAD-6E17-2443-8A68-03EDCDE4A6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6035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A8BAAD-6E17-2443-8A68-03EDCDE4A65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1621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C9FB1A-0432-6F41-A254-0F3A5E5CFC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4E413A-E6DE-6143-BEA1-8CB3C69E3E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A7E132-CBF5-C84B-B97B-C4937152D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8DA22B-83D2-EA49-B49E-10DF883E4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1684BF-2BB5-A346-AD1D-92745076D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492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61A53-02DF-8442-B917-40BCAE526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CDB62-1A00-024F-A439-5093A0DD74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374B20-A281-274E-B836-A7385848C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485313-E495-DC4E-B549-FC72FA645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06B6A6-E0B3-5B41-A984-83A1EFA74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962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59B5F6-79A2-4A4B-B0FA-5BDDC6AA20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AA358E-678E-2B4E-ABC4-76EA53DBF2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6F4A5E-AE8A-964F-86A0-74D79E2AC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7C1E37-91FA-5B41-91BA-371D51AB0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E1B9D9-A254-8643-8C6E-A4522AB20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564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6FBE7-8667-2548-AAA1-F86CE53F42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CB056-BBCF-464C-9E59-8EE569E5F2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190A50-7C83-5E4C-A738-C3CEC9317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558430-2D08-5B4D-BBEC-5810273D7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653E04-D8C9-EE4C-B776-91784E47A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427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A21FDE-CC30-4145-AEAC-7078D1AD1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9F8987-B689-CC4E-A039-7804DFA591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0A6FBE-54E5-CD48-8C4E-C845DCF2F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C6047C-C97B-5D47-BA38-FDB75169B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ACF9F5-A792-B148-9CB8-41C035512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034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91EAB-8A0C-FB40-B5C2-891E7ACAFA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E6167A-BABB-624C-95DC-DF219ED9F8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947314-FBEB-174A-B872-E2299DB6E1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809AC6-8756-464A-8152-76F0CEF82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1ED68B-072B-B143-AA7B-DB7171C12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EF6AD3-CBE5-E042-8C4E-461E14DB7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770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3B0BD3-9BE9-BA43-A9E9-D280A0D65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A0E8AF-960B-4B4F-906E-CA6D76214E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A36BD1-3BFA-9942-B204-B92065D232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0344DF-6BE6-E84C-9309-E9754BC921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89866B-D99B-344B-B229-56CEDCD0BF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BE7638-F6A1-CB45-8F57-66FC45956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042FCB-75DA-D646-ACDA-5D890DAE6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16952C-F0DA-0441-A55A-996809FF7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575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EC748-FC32-3942-93BB-87E056E95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3B330F-DA7C-C24A-82B3-9FC514AB5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8DE866-4934-4B45-983D-15D90AF03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ECADCF-6DF7-304A-BEFD-BE484E7B9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313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17465A-3B5E-BF49-BC1D-393EDF599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8EAEF7-B5A6-2548-B2A6-156847109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F37B89-C4EC-E549-B7E9-29BE8521E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18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AD00F2-E04C-354B-B70B-0C1713396B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D54DB8-8DC9-C74C-9210-8AE129FC21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ECFBD8-24D1-E34C-9C63-9D99ACDF87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50406E-57BF-E243-B6A4-7EF2AB670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2F3E71-4CD5-C540-9697-FC5034602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056DBA-FF0A-674A-8031-C818FB8C6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252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98E1F1-1A81-6146-90B6-EF7F657A73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AAD28F-4004-B94A-B70C-943C151AC5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4EA765-7CED-314B-8A9C-EBEE8091AE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DF19CA-5903-9E4A-AAAE-E0ADA9969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1F963-C515-494E-BB4A-BCAD5A2990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936D94-B134-ED43-A8DF-30FB24749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499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36A3BA-C989-F446-9A5C-3D7FC4CFA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E34EF4-AF1D-5A4C-8937-CCC124C185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FC4D3E-B5B8-0647-B854-61480F7D38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D92F5-F225-DD46-BB10-7166F464CA65}" type="datetimeFigureOut">
              <a:rPr lang="en-US" smtClean="0"/>
              <a:t>9/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CD620C-7AEB-CF46-9BFF-74B98D2DDC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8E38A6-E6E6-0645-88F7-9199F155A4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373DE-0F47-DE46-87CD-B299E11B2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027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m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m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E1DF749E-FA80-8042-B6C1-00ACB42E59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9423" t="21643" r="2084" b="18199"/>
          <a:stretch/>
        </p:blipFill>
        <p:spPr>
          <a:xfrm rot="21255889" flipH="1">
            <a:off x="2592235" y="2527553"/>
            <a:ext cx="680599" cy="11767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5F6616D-42BA-AD4A-8DA0-8A28EBDD9CD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946" t="24547" r="8929" b="17103"/>
          <a:stretch/>
        </p:blipFill>
        <p:spPr>
          <a:xfrm rot="21225964" flipH="1">
            <a:off x="9474319" y="1020356"/>
            <a:ext cx="795165" cy="136720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328A6EB-67EF-8C4E-96CD-0AB3F010AA2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1035" t="21645" r="6386" b="18317"/>
          <a:stretch/>
        </p:blipFill>
        <p:spPr>
          <a:xfrm rot="819301">
            <a:off x="4810189" y="802954"/>
            <a:ext cx="1017840" cy="1406769"/>
          </a:xfrm>
          <a:prstGeom prst="rect">
            <a:avLst/>
          </a:prstGeom>
        </p:spPr>
      </p:pic>
      <p:sp>
        <p:nvSpPr>
          <p:cNvPr id="75" name="Rectangle 74">
            <a:extLst>
              <a:ext uri="{FF2B5EF4-FFF2-40B4-BE49-F238E27FC236}">
                <a16:creationId xmlns:a16="http://schemas.microsoft.com/office/drawing/2014/main" id="{6ABB83AD-EFB1-B447-84EA-0B58D7ACAC52}"/>
              </a:ext>
            </a:extLst>
          </p:cNvPr>
          <p:cNvSpPr/>
          <p:nvPr/>
        </p:nvSpPr>
        <p:spPr>
          <a:xfrm>
            <a:off x="4470911" y="2135479"/>
            <a:ext cx="1498109" cy="1745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BB25CB5C-0A41-0D42-8147-3D7EA3D7D90E}"/>
              </a:ext>
            </a:extLst>
          </p:cNvPr>
          <p:cNvSpPr/>
          <p:nvPr/>
        </p:nvSpPr>
        <p:spPr>
          <a:xfrm>
            <a:off x="4652217" y="701830"/>
            <a:ext cx="345796" cy="16081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5F14AD2C-A40C-034C-9373-BA5F97974E66}"/>
              </a:ext>
            </a:extLst>
          </p:cNvPr>
          <p:cNvSpPr/>
          <p:nvPr/>
        </p:nvSpPr>
        <p:spPr>
          <a:xfrm>
            <a:off x="5654298" y="699977"/>
            <a:ext cx="341026" cy="16081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4135748-D5CB-4B46-97BF-AD425C37B9C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1789" t="27071" r="9772" b="21849"/>
          <a:stretch/>
        </p:blipFill>
        <p:spPr>
          <a:xfrm flipH="1">
            <a:off x="7019493" y="1032841"/>
            <a:ext cx="880407" cy="119685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B83F0C9-6965-4D4B-B27F-77C120FACA5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734" t="17934" r="73744" b="28838"/>
          <a:stretch/>
        </p:blipFill>
        <p:spPr>
          <a:xfrm>
            <a:off x="1379192" y="911228"/>
            <a:ext cx="672353" cy="124721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8AC5D5F-22AB-2443-B60D-70FDE52FDC7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0316" t="24357" r="39096" b="26281"/>
          <a:stretch/>
        </p:blipFill>
        <p:spPr>
          <a:xfrm>
            <a:off x="2086563" y="989103"/>
            <a:ext cx="643219" cy="115662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B95CC75-B0F3-AF4D-9EFC-3070CF7DF41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7601" t="23468" r="9527" b="25877"/>
          <a:stretch/>
        </p:blipFill>
        <p:spPr>
          <a:xfrm rot="277945">
            <a:off x="2751112" y="957720"/>
            <a:ext cx="714565" cy="1186903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8FBF555B-0774-E84B-8100-BA8C95C3448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894" t="25172" r="68027" b="17042"/>
          <a:stretch/>
        </p:blipFill>
        <p:spPr>
          <a:xfrm flipH="1">
            <a:off x="7955717" y="997913"/>
            <a:ext cx="737667" cy="1354017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D0ED7DD3-B671-864E-B2A8-2176127019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848" t="24171" r="41497" b="17480"/>
          <a:stretch/>
        </p:blipFill>
        <p:spPr>
          <a:xfrm rot="21421036" flipH="1">
            <a:off x="8751815" y="1002855"/>
            <a:ext cx="737666" cy="1367205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D1F4623F-86B6-0B4D-A356-B9852BE39E0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537" t="24484" r="71874" b="21781"/>
          <a:stretch/>
        </p:blipFill>
        <p:spPr>
          <a:xfrm flipH="1">
            <a:off x="5675156" y="965957"/>
            <a:ext cx="726112" cy="1259097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E50EBA10-0867-EA4A-A7F4-369F086DD56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3710" t="24654" r="43089" b="21815"/>
          <a:stretch/>
        </p:blipFill>
        <p:spPr>
          <a:xfrm flipH="1">
            <a:off x="6470867" y="957076"/>
            <a:ext cx="666017" cy="1254309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0E2ED998-EEEF-6248-AC91-4C6A76303FF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222" t="28480" r="71977" b="17719"/>
          <a:stretch/>
        </p:blipFill>
        <p:spPr>
          <a:xfrm>
            <a:off x="3523656" y="885598"/>
            <a:ext cx="681129" cy="1260634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ABB61F1E-3DDE-2748-824B-FED22D6F656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689" t="25912" r="45035" b="19172"/>
          <a:stretch/>
        </p:blipFill>
        <p:spPr>
          <a:xfrm rot="171367">
            <a:off x="4342931" y="904006"/>
            <a:ext cx="570983" cy="128678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3F31A5F-E53D-DB43-B888-E038EFCD4B38}"/>
              </a:ext>
            </a:extLst>
          </p:cNvPr>
          <p:cNvSpPr/>
          <p:nvPr/>
        </p:nvSpPr>
        <p:spPr>
          <a:xfrm>
            <a:off x="1264058" y="561926"/>
            <a:ext cx="9681979" cy="49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9F16C102-D9ED-DE46-AF85-91871225D9BF}"/>
              </a:ext>
            </a:extLst>
          </p:cNvPr>
          <p:cNvSpPr/>
          <p:nvPr/>
        </p:nvSpPr>
        <p:spPr>
          <a:xfrm>
            <a:off x="1154334" y="1825693"/>
            <a:ext cx="9681979" cy="608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0D7B975-CB38-E44B-A60C-73A77761B176}"/>
              </a:ext>
            </a:extLst>
          </p:cNvPr>
          <p:cNvSpPr txBox="1"/>
          <p:nvPr/>
        </p:nvSpPr>
        <p:spPr>
          <a:xfrm>
            <a:off x="1456783" y="1788278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17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056A622-D52A-C047-BE5B-5AF437E972A3}"/>
              </a:ext>
            </a:extLst>
          </p:cNvPr>
          <p:cNvSpPr txBox="1"/>
          <p:nvPr/>
        </p:nvSpPr>
        <p:spPr>
          <a:xfrm>
            <a:off x="2161306" y="1810107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2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1E6DBE67-F5E0-AC41-B233-2A401A1DB42A}"/>
              </a:ext>
            </a:extLst>
          </p:cNvPr>
          <p:cNvSpPr txBox="1"/>
          <p:nvPr/>
        </p:nvSpPr>
        <p:spPr>
          <a:xfrm>
            <a:off x="2873553" y="1810107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#2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0D09880-04C3-4241-B8AE-D8BB5551DA5A}"/>
              </a:ext>
            </a:extLst>
          </p:cNvPr>
          <p:cNvSpPr txBox="1"/>
          <p:nvPr/>
        </p:nvSpPr>
        <p:spPr>
          <a:xfrm>
            <a:off x="3639345" y="1825693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26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928093E-76EF-1844-8E15-06E033049E66}"/>
              </a:ext>
            </a:extLst>
          </p:cNvPr>
          <p:cNvSpPr txBox="1"/>
          <p:nvPr/>
        </p:nvSpPr>
        <p:spPr>
          <a:xfrm>
            <a:off x="4342070" y="1828585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38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EBB214D-A05E-C540-837F-DC7F36F700E5}"/>
              </a:ext>
            </a:extLst>
          </p:cNvPr>
          <p:cNvSpPr txBox="1"/>
          <p:nvPr/>
        </p:nvSpPr>
        <p:spPr>
          <a:xfrm>
            <a:off x="5092824" y="1829265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48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AF07909-A1C3-E84F-8B32-C3BB1CB76C62}"/>
              </a:ext>
            </a:extLst>
          </p:cNvPr>
          <p:cNvSpPr txBox="1"/>
          <p:nvPr/>
        </p:nvSpPr>
        <p:spPr>
          <a:xfrm>
            <a:off x="5825227" y="1838710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5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6F0944C-F8BC-E34A-9AF4-03ADB086D1F7}"/>
              </a:ext>
            </a:extLst>
          </p:cNvPr>
          <p:cNvSpPr txBox="1"/>
          <p:nvPr/>
        </p:nvSpPr>
        <p:spPr>
          <a:xfrm>
            <a:off x="6589983" y="1838710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52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2171F38-380E-854D-A9CC-12AFC0416771}"/>
              </a:ext>
            </a:extLst>
          </p:cNvPr>
          <p:cNvSpPr txBox="1"/>
          <p:nvPr/>
        </p:nvSpPr>
        <p:spPr>
          <a:xfrm>
            <a:off x="7316864" y="1851855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57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5907D24-6968-D645-BBF1-454EA3C9C4ED}"/>
              </a:ext>
            </a:extLst>
          </p:cNvPr>
          <p:cNvSpPr txBox="1"/>
          <p:nvPr/>
        </p:nvSpPr>
        <p:spPr>
          <a:xfrm>
            <a:off x="8101297" y="1870804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58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EF6A0B8-9323-0B4C-AC95-7F8FCD0EEB0D}"/>
              </a:ext>
            </a:extLst>
          </p:cNvPr>
          <p:cNvSpPr txBox="1"/>
          <p:nvPr/>
        </p:nvSpPr>
        <p:spPr>
          <a:xfrm>
            <a:off x="8914292" y="1883608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61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AA6DF1E-7DA6-AF47-866F-61D910D5FA78}"/>
              </a:ext>
            </a:extLst>
          </p:cNvPr>
          <p:cNvSpPr txBox="1"/>
          <p:nvPr/>
        </p:nvSpPr>
        <p:spPr>
          <a:xfrm>
            <a:off x="9707390" y="1900935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64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4FB81C8-A3EA-4441-9979-777EF2475E0B}"/>
              </a:ext>
            </a:extLst>
          </p:cNvPr>
          <p:cNvSpPr/>
          <p:nvPr/>
        </p:nvSpPr>
        <p:spPr>
          <a:xfrm>
            <a:off x="2023148" y="911228"/>
            <a:ext cx="176408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0E4752BD-DD4A-5544-8C38-2701287CA954}"/>
              </a:ext>
            </a:extLst>
          </p:cNvPr>
          <p:cNvSpPr/>
          <p:nvPr/>
        </p:nvSpPr>
        <p:spPr>
          <a:xfrm>
            <a:off x="1297697" y="946019"/>
            <a:ext cx="176408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F4DA42DC-F40E-8F40-B8F1-F8FCDB147651}"/>
              </a:ext>
            </a:extLst>
          </p:cNvPr>
          <p:cNvSpPr/>
          <p:nvPr/>
        </p:nvSpPr>
        <p:spPr>
          <a:xfrm>
            <a:off x="2699033" y="836021"/>
            <a:ext cx="208862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7C042602-A429-EA48-B229-623EC34C56F4}"/>
              </a:ext>
            </a:extLst>
          </p:cNvPr>
          <p:cNvSpPr/>
          <p:nvPr/>
        </p:nvSpPr>
        <p:spPr>
          <a:xfrm>
            <a:off x="3399816" y="993263"/>
            <a:ext cx="241464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CAAFE3BA-209C-3645-AB8F-0053DA393237}"/>
              </a:ext>
            </a:extLst>
          </p:cNvPr>
          <p:cNvSpPr/>
          <p:nvPr/>
        </p:nvSpPr>
        <p:spPr>
          <a:xfrm>
            <a:off x="4231116" y="962732"/>
            <a:ext cx="167130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E673A415-36F2-5D4E-8561-56DAAE26DE94}"/>
              </a:ext>
            </a:extLst>
          </p:cNvPr>
          <p:cNvSpPr/>
          <p:nvPr/>
        </p:nvSpPr>
        <p:spPr>
          <a:xfrm>
            <a:off x="4922535" y="978598"/>
            <a:ext cx="204389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3FEE129F-C68D-F546-8B55-3FC767740384}"/>
              </a:ext>
            </a:extLst>
          </p:cNvPr>
          <p:cNvSpPr/>
          <p:nvPr/>
        </p:nvSpPr>
        <p:spPr>
          <a:xfrm>
            <a:off x="5651967" y="837544"/>
            <a:ext cx="174118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B662483D-D9B3-104A-8EBD-2BD9CB51504B}"/>
              </a:ext>
            </a:extLst>
          </p:cNvPr>
          <p:cNvSpPr/>
          <p:nvPr/>
        </p:nvSpPr>
        <p:spPr>
          <a:xfrm>
            <a:off x="6386001" y="843144"/>
            <a:ext cx="204389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BCF3671A-67D9-914E-9FFE-6F88FC000F75}"/>
              </a:ext>
            </a:extLst>
          </p:cNvPr>
          <p:cNvSpPr/>
          <p:nvPr/>
        </p:nvSpPr>
        <p:spPr>
          <a:xfrm>
            <a:off x="7131786" y="887124"/>
            <a:ext cx="204389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E4311365-BDCF-9C4E-86A3-8FA667696103}"/>
              </a:ext>
            </a:extLst>
          </p:cNvPr>
          <p:cNvSpPr/>
          <p:nvPr/>
        </p:nvSpPr>
        <p:spPr>
          <a:xfrm>
            <a:off x="7893379" y="866923"/>
            <a:ext cx="204389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C60AD7B3-077F-514D-B9F5-5748C11D81D5}"/>
              </a:ext>
            </a:extLst>
          </p:cNvPr>
          <p:cNvSpPr/>
          <p:nvPr/>
        </p:nvSpPr>
        <p:spPr>
          <a:xfrm>
            <a:off x="8681924" y="936531"/>
            <a:ext cx="204389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4CB559D8-07EA-4E44-836E-31EF487F0F2C}"/>
              </a:ext>
            </a:extLst>
          </p:cNvPr>
          <p:cNvSpPr/>
          <p:nvPr/>
        </p:nvSpPr>
        <p:spPr>
          <a:xfrm>
            <a:off x="9457177" y="950247"/>
            <a:ext cx="250213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67343180-3BF2-F542-8E97-AF6D798AA200}"/>
              </a:ext>
            </a:extLst>
          </p:cNvPr>
          <p:cNvSpPr/>
          <p:nvPr/>
        </p:nvSpPr>
        <p:spPr>
          <a:xfrm>
            <a:off x="10219211" y="1017392"/>
            <a:ext cx="271147" cy="117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3945CE6-7029-8346-9046-5DB2F0ECDC4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13" t="27710" r="71596" b="15265"/>
          <a:stretch/>
        </p:blipFill>
        <p:spPr>
          <a:xfrm flipH="1">
            <a:off x="1335486" y="2491047"/>
            <a:ext cx="612565" cy="1082747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EEFF164-C0A5-0F47-9956-BA015B6CCFA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342" t="16819" r="34461" b="22447"/>
          <a:stretch/>
        </p:blipFill>
        <p:spPr>
          <a:xfrm rot="21395773" flipH="1">
            <a:off x="1999216" y="2474593"/>
            <a:ext cx="607890" cy="122019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20960450-0357-7549-B7C5-6D43E16B76A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6816" r="76145" b="8965"/>
          <a:stretch/>
        </p:blipFill>
        <p:spPr>
          <a:xfrm>
            <a:off x="3337358" y="2461068"/>
            <a:ext cx="520062" cy="1213546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A5365DCE-6C98-B44A-9086-8BB5E143D09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5699" t="17814" r="38205" b="8686"/>
          <a:stretch/>
        </p:blipFill>
        <p:spPr>
          <a:xfrm rot="307788">
            <a:off x="3958940" y="2475855"/>
            <a:ext cx="561547" cy="118620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D6184FA-325E-B94A-9104-13C8DE9FB9A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9585" t="16657" r="4319" b="11759"/>
          <a:stretch/>
        </p:blipFill>
        <p:spPr>
          <a:xfrm>
            <a:off x="4495959" y="2457600"/>
            <a:ext cx="598669" cy="1231664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65A0E952-D495-A144-BC7A-632B69C776B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722" t="14877" r="70666" b="9371"/>
          <a:stretch/>
        </p:blipFill>
        <p:spPr>
          <a:xfrm>
            <a:off x="5803474" y="2437220"/>
            <a:ext cx="483306" cy="1162956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BC8E6758-0D8F-8943-A605-8725AB7BB40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6056" t="14984" r="40333" b="9262"/>
          <a:stretch/>
        </p:blipFill>
        <p:spPr>
          <a:xfrm>
            <a:off x="6798707" y="2408454"/>
            <a:ext cx="501164" cy="12059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F0AE8DC-E71E-D746-9127-89E2E7DB0AF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72384" t="19521" r="4004" b="7677"/>
          <a:stretch/>
        </p:blipFill>
        <p:spPr>
          <a:xfrm>
            <a:off x="7709443" y="2471992"/>
            <a:ext cx="496065" cy="1147151"/>
          </a:xfrm>
          <a:prstGeom prst="rect">
            <a:avLst/>
          </a:prstGeom>
        </p:spPr>
      </p:pic>
      <p:sp>
        <p:nvSpPr>
          <p:cNvPr id="115" name="Rectangle 114">
            <a:extLst>
              <a:ext uri="{FF2B5EF4-FFF2-40B4-BE49-F238E27FC236}">
                <a16:creationId xmlns:a16="http://schemas.microsoft.com/office/drawing/2014/main" id="{DEABA5B9-DB08-9C42-8D64-3389F7B733D4}"/>
              </a:ext>
            </a:extLst>
          </p:cNvPr>
          <p:cNvSpPr/>
          <p:nvPr/>
        </p:nvSpPr>
        <p:spPr>
          <a:xfrm>
            <a:off x="1206593" y="2355275"/>
            <a:ext cx="267512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5E3170DE-ACF3-E64C-A3D8-DB04A4FFE225}"/>
              </a:ext>
            </a:extLst>
          </p:cNvPr>
          <p:cNvSpPr/>
          <p:nvPr/>
        </p:nvSpPr>
        <p:spPr>
          <a:xfrm>
            <a:off x="983821" y="2170426"/>
            <a:ext cx="9681979" cy="3757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DAE2574D-57B9-3545-AD05-D58B3DB9BC92}"/>
              </a:ext>
            </a:extLst>
          </p:cNvPr>
          <p:cNvSpPr/>
          <p:nvPr/>
        </p:nvSpPr>
        <p:spPr>
          <a:xfrm>
            <a:off x="651415" y="3353963"/>
            <a:ext cx="9681979" cy="5619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CA0C9E3D-9EB3-4747-9EC8-BC160D8F90D7}"/>
              </a:ext>
            </a:extLst>
          </p:cNvPr>
          <p:cNvSpPr/>
          <p:nvPr/>
        </p:nvSpPr>
        <p:spPr>
          <a:xfrm>
            <a:off x="1925219" y="2324776"/>
            <a:ext cx="182387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8102B51E-D9E6-AA4B-815A-196F0B7D3A2A}"/>
              </a:ext>
            </a:extLst>
          </p:cNvPr>
          <p:cNvSpPr/>
          <p:nvPr/>
        </p:nvSpPr>
        <p:spPr>
          <a:xfrm>
            <a:off x="2566915" y="2351269"/>
            <a:ext cx="214670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AA85B91F-90E6-D44D-84AA-8D54E293E2C1}"/>
              </a:ext>
            </a:extLst>
          </p:cNvPr>
          <p:cNvSpPr/>
          <p:nvPr/>
        </p:nvSpPr>
        <p:spPr>
          <a:xfrm>
            <a:off x="3224147" y="2362177"/>
            <a:ext cx="207946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28FAD70F-5E6B-E943-8F89-EC30593685D7}"/>
              </a:ext>
            </a:extLst>
          </p:cNvPr>
          <p:cNvSpPr/>
          <p:nvPr/>
        </p:nvSpPr>
        <p:spPr>
          <a:xfrm>
            <a:off x="3848998" y="2270267"/>
            <a:ext cx="198547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C33BC240-5169-9244-86C6-53DA94AE8EAC}"/>
              </a:ext>
            </a:extLst>
          </p:cNvPr>
          <p:cNvSpPr/>
          <p:nvPr/>
        </p:nvSpPr>
        <p:spPr>
          <a:xfrm>
            <a:off x="4458192" y="2372867"/>
            <a:ext cx="202525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861C865-125F-294D-BAF4-770B46326A84}"/>
              </a:ext>
            </a:extLst>
          </p:cNvPr>
          <p:cNvSpPr txBox="1"/>
          <p:nvPr/>
        </p:nvSpPr>
        <p:spPr>
          <a:xfrm>
            <a:off x="1384788" y="3324017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67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10CDFE2-17FA-DE42-9FF3-86BCB20D0CBD}"/>
              </a:ext>
            </a:extLst>
          </p:cNvPr>
          <p:cNvSpPr txBox="1"/>
          <p:nvPr/>
        </p:nvSpPr>
        <p:spPr>
          <a:xfrm>
            <a:off x="2041504" y="3324017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72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D02A716-581C-664E-9783-8CFA5D98D272}"/>
              </a:ext>
            </a:extLst>
          </p:cNvPr>
          <p:cNvSpPr txBox="1"/>
          <p:nvPr/>
        </p:nvSpPr>
        <p:spPr>
          <a:xfrm>
            <a:off x="2727459" y="3337653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8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4A06B12-A720-C640-AE62-8A30CC73C906}"/>
              </a:ext>
            </a:extLst>
          </p:cNvPr>
          <p:cNvSpPr txBox="1"/>
          <p:nvPr/>
        </p:nvSpPr>
        <p:spPr>
          <a:xfrm>
            <a:off x="3340385" y="3348137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83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A61568C-8211-B049-9DE2-5A7E35A14CFA}"/>
              </a:ext>
            </a:extLst>
          </p:cNvPr>
          <p:cNvSpPr txBox="1"/>
          <p:nvPr/>
        </p:nvSpPr>
        <p:spPr>
          <a:xfrm>
            <a:off x="3951701" y="3350561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85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B6F4988-64CD-DC4F-82D4-187F87787D03}"/>
              </a:ext>
            </a:extLst>
          </p:cNvPr>
          <p:cNvSpPr txBox="1"/>
          <p:nvPr/>
        </p:nvSpPr>
        <p:spPr>
          <a:xfrm>
            <a:off x="4576130" y="3343677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86</a:t>
            </a: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ABCB7B61-B0FF-5D45-873E-C9DF03121587}"/>
              </a:ext>
            </a:extLst>
          </p:cNvPr>
          <p:cNvSpPr/>
          <p:nvPr/>
        </p:nvSpPr>
        <p:spPr>
          <a:xfrm>
            <a:off x="5633452" y="2413431"/>
            <a:ext cx="202525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4CA103DA-84FF-5443-81FE-1A9D1B9BE59F}"/>
              </a:ext>
            </a:extLst>
          </p:cNvPr>
          <p:cNvSpPr/>
          <p:nvPr/>
        </p:nvSpPr>
        <p:spPr>
          <a:xfrm>
            <a:off x="6624153" y="2247080"/>
            <a:ext cx="202525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8B5DD41-0846-5B44-A827-7B73C56FA989}"/>
              </a:ext>
            </a:extLst>
          </p:cNvPr>
          <p:cNvSpPr txBox="1"/>
          <p:nvPr/>
        </p:nvSpPr>
        <p:spPr>
          <a:xfrm>
            <a:off x="5761860" y="3385360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edia</a:t>
            </a: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178F2976-A703-4744-96DA-95010C20EC17}"/>
              </a:ext>
            </a:extLst>
          </p:cNvPr>
          <p:cNvSpPr/>
          <p:nvPr/>
        </p:nvSpPr>
        <p:spPr>
          <a:xfrm>
            <a:off x="7232054" y="2299215"/>
            <a:ext cx="202525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726CBE65-9691-A94A-9021-8DD4664433C0}"/>
              </a:ext>
            </a:extLst>
          </p:cNvPr>
          <p:cNvSpPr txBox="1"/>
          <p:nvPr/>
        </p:nvSpPr>
        <p:spPr>
          <a:xfrm>
            <a:off x="6558635" y="3353601"/>
            <a:ext cx="9943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ommercial </a:t>
            </a:r>
          </a:p>
          <a:p>
            <a:r>
              <a:rPr lang="en-US" sz="1200" dirty="0"/>
              <a:t>Anti-NP </a:t>
            </a:r>
            <a:r>
              <a:rPr lang="en-US" sz="1200" dirty="0" err="1"/>
              <a:t>mAb</a:t>
            </a:r>
            <a:endParaRPr lang="en-US" sz="1200" dirty="0"/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EA6BB871-DB59-B044-84C8-F27FBF517F76}"/>
              </a:ext>
            </a:extLst>
          </p:cNvPr>
          <p:cNvSpPr/>
          <p:nvPr/>
        </p:nvSpPr>
        <p:spPr>
          <a:xfrm>
            <a:off x="5067764" y="2294830"/>
            <a:ext cx="202525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C4DCF68F-5994-8B47-BD32-D3027A20B7C0}"/>
              </a:ext>
            </a:extLst>
          </p:cNvPr>
          <p:cNvSpPr/>
          <p:nvPr/>
        </p:nvSpPr>
        <p:spPr>
          <a:xfrm>
            <a:off x="7594966" y="2379263"/>
            <a:ext cx="202525" cy="16210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9C03593E-DB78-E843-94E7-E34EAEF6A055}"/>
              </a:ext>
            </a:extLst>
          </p:cNvPr>
          <p:cNvSpPr txBox="1"/>
          <p:nvPr/>
        </p:nvSpPr>
        <p:spPr>
          <a:xfrm>
            <a:off x="7614854" y="3357117"/>
            <a:ext cx="938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nti-6xHi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6124BA0-C911-5448-8927-9DCCDCCD039D}"/>
              </a:ext>
            </a:extLst>
          </p:cNvPr>
          <p:cNvSpPr txBox="1"/>
          <p:nvPr/>
        </p:nvSpPr>
        <p:spPr>
          <a:xfrm>
            <a:off x="1418987" y="761353"/>
            <a:ext cx="6306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NRV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5C9827-610D-8A4B-AA68-4C529063477F}"/>
              </a:ext>
            </a:extLst>
          </p:cNvPr>
          <p:cNvSpPr txBox="1"/>
          <p:nvPr/>
        </p:nvSpPr>
        <p:spPr>
          <a:xfrm>
            <a:off x="8510803" y="2594425"/>
            <a:ext cx="259680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 = Recombinant nucleocapsid protein</a:t>
            </a:r>
          </a:p>
          <a:p>
            <a:r>
              <a:rPr lang="en-US" sz="1200" dirty="0"/>
              <a:t>R = His-tagged SARS_CoV-2 Spike RBD </a:t>
            </a:r>
          </a:p>
          <a:p>
            <a:r>
              <a:rPr lang="en-US" sz="1200" dirty="0"/>
              <a:t>V = uninfected Vero cell lysate</a:t>
            </a:r>
          </a:p>
          <a:p>
            <a:r>
              <a:rPr lang="en-US" sz="1200" dirty="0"/>
              <a:t>L = Molecular weight ladder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C1634AF-53B9-8F44-A63E-6A1E8DAFD10B}"/>
              </a:ext>
            </a:extLst>
          </p:cNvPr>
          <p:cNvSpPr txBox="1"/>
          <p:nvPr/>
        </p:nvSpPr>
        <p:spPr>
          <a:xfrm>
            <a:off x="1363909" y="2251945"/>
            <a:ext cx="684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RVL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905120C8-50DB-7540-9696-8E56CCEA4B7F}"/>
              </a:ext>
            </a:extLst>
          </p:cNvPr>
          <p:cNvSpPr txBox="1"/>
          <p:nvPr/>
        </p:nvSpPr>
        <p:spPr>
          <a:xfrm>
            <a:off x="7718537" y="2305535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RV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3F8A667-E63A-C740-A8F9-FAC14D471B9F}"/>
              </a:ext>
            </a:extLst>
          </p:cNvPr>
          <p:cNvSpPr txBox="1"/>
          <p:nvPr/>
        </p:nvSpPr>
        <p:spPr>
          <a:xfrm>
            <a:off x="701141" y="4923994"/>
            <a:ext cx="92065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. Western blot analysis of anti-SARS-CoV-2 N protein monoclonal antibodies against recombinant antigen</a:t>
            </a:r>
          </a:p>
        </p:txBody>
      </p:sp>
    </p:spTree>
    <p:extLst>
      <p:ext uri="{BB962C8B-B14F-4D97-AF65-F5344CB8AC3E}">
        <p14:creationId xmlns:p14="http://schemas.microsoft.com/office/powerpoint/2010/main" val="25803644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3F8A667-E63A-C740-A8F9-FAC14D471B9F}"/>
              </a:ext>
            </a:extLst>
          </p:cNvPr>
          <p:cNvSpPr txBox="1"/>
          <p:nvPr/>
        </p:nvSpPr>
        <p:spPr>
          <a:xfrm>
            <a:off x="2194560" y="5324438"/>
            <a:ext cx="82092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2. IFA images of SARS-CoV-2 infected and uninfected cells stained with control rabbit anti-NP polyclonal antibody. Images obtained with a </a:t>
            </a:r>
            <a:r>
              <a:rPr lang="en-US" sz="1800" b="1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eligo</a:t>
            </a:r>
            <a:r>
              <a:rPr lang="en-US" sz="18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 high-content imaging cytometer (</a:t>
            </a:r>
            <a:r>
              <a:rPr lang="en-US" sz="1800" b="1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excelcom</a:t>
            </a:r>
            <a:r>
              <a:rPr lang="en-US" sz="18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</a:t>
            </a:r>
            <a:endParaRPr lang="en-US" b="1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1BD1828-68BC-4575-A7ED-5B433E2313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58649" y="486065"/>
            <a:ext cx="4874699" cy="219217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56D6D96-3677-4471-97A8-C6C9B419EFB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024"/>
          <a:stretch/>
        </p:blipFill>
        <p:spPr>
          <a:xfrm>
            <a:off x="3658650" y="2791316"/>
            <a:ext cx="4874699" cy="2215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3294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6FFCE43-38C5-F64F-AC18-85DAFA548962}"/>
              </a:ext>
            </a:extLst>
          </p:cNvPr>
          <p:cNvSpPr txBox="1"/>
          <p:nvPr/>
        </p:nvSpPr>
        <p:spPr>
          <a:xfrm>
            <a:off x="1147885" y="6118845"/>
            <a:ext cx="6479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1. DNA </a:t>
            </a:r>
            <a:r>
              <a:rPr lang="en-US" b="1" dirty="0" err="1"/>
              <a:t>gBlocks</a:t>
            </a:r>
            <a:r>
              <a:rPr lang="en-US" b="1" dirty="0"/>
              <a:t> and oligonucleotide primer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B81DFB4-086D-426D-865C-A043E8EB7E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2492" y="554489"/>
            <a:ext cx="9687016" cy="5282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5320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6</Words>
  <Application>Microsoft Macintosh PowerPoint</Application>
  <PresentationFormat>Widescreen</PresentationFormat>
  <Paragraphs>34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iss,Brian</dc:creator>
  <cp:lastModifiedBy>Geiss,Brian</cp:lastModifiedBy>
  <cp:revision>2</cp:revision>
  <dcterms:created xsi:type="dcterms:W3CDTF">2020-09-03T12:45:43Z</dcterms:created>
  <dcterms:modified xsi:type="dcterms:W3CDTF">2020-09-03T12:49:25Z</dcterms:modified>
</cp:coreProperties>
</file>